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56" r:id="rId2"/>
  </p:sldIdLst>
  <p:sldSz cx="9144000" cy="1079976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1" d="100"/>
          <a:sy n="71" d="100"/>
        </p:scale>
        <p:origin x="203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E3A74FE-B1BA-4FB6-B4F3-BBE850B2D3CB}" type="datetimeFigureOut">
              <a:rPr lang="ko-KR" altLang="en-US" smtClean="0"/>
              <a:t>2017-01-0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22488" y="1143000"/>
            <a:ext cx="26130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A4ABD56-AA30-4791-AA0C-D75710DE641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74121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2122488" y="1143000"/>
            <a:ext cx="2613025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A4ABD56-AA30-4791-AA0C-D75710DE6410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958408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767462"/>
            <a:ext cx="7772400" cy="375991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5672376"/>
            <a:ext cx="6858000" cy="260744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7C07B-45D3-4C82-9618-6E1287E2D93B}" type="datetimeFigureOut">
              <a:rPr lang="ko-KR" altLang="en-US" smtClean="0"/>
              <a:t>2017-01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2AF493-4298-4BF5-A3AE-719B0A03FD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97022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7C07B-45D3-4C82-9618-6E1287E2D93B}" type="datetimeFigureOut">
              <a:rPr lang="ko-KR" altLang="en-US" smtClean="0"/>
              <a:t>2017-01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2AF493-4298-4BF5-A3AE-719B0A03FD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221079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574987"/>
            <a:ext cx="1971675" cy="9152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574987"/>
            <a:ext cx="5800725" cy="9152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7C07B-45D3-4C82-9618-6E1287E2D93B}" type="datetimeFigureOut">
              <a:rPr lang="ko-KR" altLang="en-US" smtClean="0"/>
              <a:t>2017-01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2AF493-4298-4BF5-A3AE-719B0A03FD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522858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7C07B-45D3-4C82-9618-6E1287E2D93B}" type="datetimeFigureOut">
              <a:rPr lang="ko-KR" altLang="en-US" smtClean="0"/>
              <a:t>2017-01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2AF493-4298-4BF5-A3AE-719B0A03FD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10980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2692444"/>
            <a:ext cx="7886700" cy="4492401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7227345"/>
            <a:ext cx="7886700" cy="236244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7C07B-45D3-4C82-9618-6E1287E2D93B}" type="datetimeFigureOut">
              <a:rPr lang="ko-KR" altLang="en-US" smtClean="0"/>
              <a:t>2017-01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2AF493-4298-4BF5-A3AE-719B0A03FD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78503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2874937"/>
            <a:ext cx="3886200" cy="6852350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2874937"/>
            <a:ext cx="3886200" cy="6852350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7C07B-45D3-4C82-9618-6E1287E2D93B}" type="datetimeFigureOut">
              <a:rPr lang="ko-KR" altLang="en-US" smtClean="0"/>
              <a:t>2017-01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2AF493-4298-4BF5-A3AE-719B0A03FD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52086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574990"/>
            <a:ext cx="7886700" cy="208745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2647443"/>
            <a:ext cx="3868340" cy="129747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3944914"/>
            <a:ext cx="3868340" cy="580237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2647443"/>
            <a:ext cx="3887391" cy="129747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3944914"/>
            <a:ext cx="3887391" cy="580237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7C07B-45D3-4C82-9618-6E1287E2D93B}" type="datetimeFigureOut">
              <a:rPr lang="ko-KR" altLang="en-US" smtClean="0"/>
              <a:t>2017-01-09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2AF493-4298-4BF5-A3AE-719B0A03FD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52151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7C07B-45D3-4C82-9618-6E1287E2D93B}" type="datetimeFigureOut">
              <a:rPr lang="ko-KR" altLang="en-US" smtClean="0"/>
              <a:t>2017-01-09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2AF493-4298-4BF5-A3AE-719B0A03FD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456714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7C07B-45D3-4C82-9618-6E1287E2D93B}" type="datetimeFigureOut">
              <a:rPr lang="ko-KR" altLang="en-US" smtClean="0"/>
              <a:t>2017-01-09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2AF493-4298-4BF5-A3AE-719B0A03FD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078751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719984"/>
            <a:ext cx="2949178" cy="2519945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554968"/>
            <a:ext cx="4629150" cy="7674832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239929"/>
            <a:ext cx="2949178" cy="6002369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7C07B-45D3-4C82-9618-6E1287E2D93B}" type="datetimeFigureOut">
              <a:rPr lang="ko-KR" altLang="en-US" smtClean="0"/>
              <a:t>2017-01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2AF493-4298-4BF5-A3AE-719B0A03FD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29662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719984"/>
            <a:ext cx="2949178" cy="2519945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554968"/>
            <a:ext cx="4629150" cy="7674832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239929"/>
            <a:ext cx="2949178" cy="6002369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7C07B-45D3-4C82-9618-6E1287E2D93B}" type="datetimeFigureOut">
              <a:rPr lang="ko-KR" altLang="en-US" smtClean="0"/>
              <a:t>2017-01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2AF493-4298-4BF5-A3AE-719B0A03FD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94785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574990"/>
            <a:ext cx="7886700" cy="2087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2874937"/>
            <a:ext cx="7886700" cy="68523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10009783"/>
            <a:ext cx="2057400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87C07B-45D3-4C82-9618-6E1287E2D93B}" type="datetimeFigureOut">
              <a:rPr lang="ko-KR" altLang="en-US" smtClean="0"/>
              <a:t>2017-01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10009783"/>
            <a:ext cx="3086100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10009783"/>
            <a:ext cx="2057400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2AF493-4298-4BF5-A3AE-719B0A03FD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521897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24" Type="http://schemas.openxmlformats.org/officeDocument/2006/relationships/image" Target="../media/image22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23" Type="http://schemas.openxmlformats.org/officeDocument/2006/relationships/image" Target="../media/image21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 rot="10800000">
            <a:off x="347939" y="1127837"/>
            <a:ext cx="369332" cy="586595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week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9" name="TextBox 128"/>
          <p:cNvSpPr txBox="1"/>
          <p:nvPr/>
        </p:nvSpPr>
        <p:spPr>
          <a:xfrm rot="16200000">
            <a:off x="1438022" y="-48510"/>
            <a:ext cx="369332" cy="955215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fault view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0" name="그림 129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099" r="26032"/>
          <a:stretch/>
        </p:blipFill>
        <p:spPr>
          <a:xfrm>
            <a:off x="734523" y="729381"/>
            <a:ext cx="1828800" cy="1694053"/>
          </a:xfrm>
          <a:prstGeom prst="rect">
            <a:avLst/>
          </a:prstGeom>
        </p:spPr>
      </p:pic>
      <p:pic>
        <p:nvPicPr>
          <p:cNvPr id="131" name="그림 130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472" t="6489" r="31135" b="7996"/>
          <a:stretch/>
        </p:blipFill>
        <p:spPr>
          <a:xfrm>
            <a:off x="2695517" y="729379"/>
            <a:ext cx="1874765" cy="1735550"/>
          </a:xfrm>
          <a:prstGeom prst="rect">
            <a:avLst/>
          </a:prstGeom>
        </p:spPr>
      </p:pic>
      <p:sp>
        <p:nvSpPr>
          <p:cNvPr id="132" name="TextBox 131"/>
          <p:cNvSpPr txBox="1"/>
          <p:nvPr/>
        </p:nvSpPr>
        <p:spPr>
          <a:xfrm rot="16200000">
            <a:off x="3448231" y="85325"/>
            <a:ext cx="369332" cy="68754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p view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3" name="그림 132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084" t="19723" r="32838" b="11970"/>
          <a:stretch/>
        </p:blipFill>
        <p:spPr>
          <a:xfrm>
            <a:off x="4778304" y="729380"/>
            <a:ext cx="1794781" cy="1694053"/>
          </a:xfrm>
          <a:prstGeom prst="rect">
            <a:avLst/>
          </a:prstGeom>
        </p:spPr>
      </p:pic>
      <p:sp>
        <p:nvSpPr>
          <p:cNvPr id="134" name="TextBox 133"/>
          <p:cNvSpPr txBox="1"/>
          <p:nvPr/>
        </p:nvSpPr>
        <p:spPr>
          <a:xfrm rot="16200000">
            <a:off x="5491025" y="-21115"/>
            <a:ext cx="369332" cy="900425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ght view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5" name="그림 134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07" t="19538" r="32838" b="12339"/>
          <a:stretch/>
        </p:blipFill>
        <p:spPr>
          <a:xfrm>
            <a:off x="6702864" y="729380"/>
            <a:ext cx="2001644" cy="1694053"/>
          </a:xfrm>
          <a:prstGeom prst="rect">
            <a:avLst/>
          </a:prstGeom>
        </p:spPr>
      </p:pic>
      <p:sp>
        <p:nvSpPr>
          <p:cNvPr id="136" name="TextBox 135"/>
          <p:cNvSpPr txBox="1"/>
          <p:nvPr/>
        </p:nvSpPr>
        <p:spPr>
          <a:xfrm rot="16200000">
            <a:off x="7640261" y="-21116"/>
            <a:ext cx="369332" cy="900425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ft view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7" name="그림 136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940" r="27467"/>
          <a:stretch/>
        </p:blipFill>
        <p:spPr>
          <a:xfrm>
            <a:off x="868425" y="2539049"/>
            <a:ext cx="1694898" cy="1722270"/>
          </a:xfrm>
          <a:prstGeom prst="rect">
            <a:avLst/>
          </a:prstGeom>
        </p:spPr>
      </p:pic>
      <p:pic>
        <p:nvPicPr>
          <p:cNvPr id="138" name="그림 137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176" t="8423" r="33298" b="8804"/>
          <a:stretch/>
        </p:blipFill>
        <p:spPr>
          <a:xfrm>
            <a:off x="2624731" y="2539051"/>
            <a:ext cx="1945551" cy="1823691"/>
          </a:xfrm>
          <a:prstGeom prst="rect">
            <a:avLst/>
          </a:prstGeom>
        </p:spPr>
      </p:pic>
      <p:pic>
        <p:nvPicPr>
          <p:cNvPr id="139" name="그림 138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314" t="19485" r="33145" b="11475"/>
          <a:stretch/>
        </p:blipFill>
        <p:spPr>
          <a:xfrm>
            <a:off x="4778302" y="2539048"/>
            <a:ext cx="1831698" cy="1722272"/>
          </a:xfrm>
          <a:prstGeom prst="rect">
            <a:avLst/>
          </a:prstGeom>
        </p:spPr>
      </p:pic>
      <p:pic>
        <p:nvPicPr>
          <p:cNvPr id="140" name="그림 139"/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091" t="19485" r="33375" b="12238"/>
          <a:stretch/>
        </p:blipFill>
        <p:spPr>
          <a:xfrm>
            <a:off x="6664722" y="2539047"/>
            <a:ext cx="2039786" cy="1722272"/>
          </a:xfrm>
          <a:prstGeom prst="rect">
            <a:avLst/>
          </a:prstGeom>
        </p:spPr>
      </p:pic>
      <p:sp>
        <p:nvSpPr>
          <p:cNvPr id="141" name="TextBox 140"/>
          <p:cNvSpPr txBox="1"/>
          <p:nvPr/>
        </p:nvSpPr>
        <p:spPr>
          <a:xfrm rot="10800000">
            <a:off x="345621" y="2954485"/>
            <a:ext cx="369332" cy="66973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weeks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2" name="그림 141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050" r="24397"/>
          <a:stretch/>
        </p:blipFill>
        <p:spPr>
          <a:xfrm>
            <a:off x="855741" y="4436862"/>
            <a:ext cx="1707582" cy="1769902"/>
          </a:xfrm>
          <a:prstGeom prst="rect">
            <a:avLst/>
          </a:prstGeom>
        </p:spPr>
      </p:pic>
      <p:sp>
        <p:nvSpPr>
          <p:cNvPr id="143" name="TextBox 142"/>
          <p:cNvSpPr txBox="1"/>
          <p:nvPr/>
        </p:nvSpPr>
        <p:spPr>
          <a:xfrm rot="10800000">
            <a:off x="345621" y="4836625"/>
            <a:ext cx="369332" cy="63925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weeks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4" name="그림 143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33" t="8310" r="30382" b="8168"/>
          <a:stretch/>
        </p:blipFill>
        <p:spPr>
          <a:xfrm>
            <a:off x="2624731" y="4436863"/>
            <a:ext cx="1945551" cy="1836145"/>
          </a:xfrm>
          <a:prstGeom prst="rect">
            <a:avLst/>
          </a:prstGeom>
        </p:spPr>
      </p:pic>
      <p:pic>
        <p:nvPicPr>
          <p:cNvPr id="145" name="그림 144"/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369" t="19718" r="30161" b="11738"/>
          <a:stretch/>
        </p:blipFill>
        <p:spPr>
          <a:xfrm>
            <a:off x="4778303" y="4474171"/>
            <a:ext cx="1876147" cy="1761527"/>
          </a:xfrm>
          <a:prstGeom prst="rect">
            <a:avLst/>
          </a:prstGeom>
        </p:spPr>
      </p:pic>
      <p:pic>
        <p:nvPicPr>
          <p:cNvPr id="146" name="그림 145"/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713" t="19483" r="30937" b="12206"/>
          <a:stretch/>
        </p:blipFill>
        <p:spPr>
          <a:xfrm>
            <a:off x="6664722" y="4474170"/>
            <a:ext cx="2009378" cy="1735100"/>
          </a:xfrm>
          <a:prstGeom prst="rect">
            <a:avLst/>
          </a:prstGeom>
        </p:spPr>
      </p:pic>
      <p:pic>
        <p:nvPicPr>
          <p:cNvPr id="147" name="그림 146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158" r="28055"/>
          <a:stretch/>
        </p:blipFill>
        <p:spPr>
          <a:xfrm>
            <a:off x="703820" y="6382308"/>
            <a:ext cx="1890207" cy="1768217"/>
          </a:xfrm>
          <a:prstGeom prst="rect">
            <a:avLst/>
          </a:prstGeom>
        </p:spPr>
      </p:pic>
      <p:sp>
        <p:nvSpPr>
          <p:cNvPr id="148" name="TextBox 147"/>
          <p:cNvSpPr txBox="1"/>
          <p:nvPr/>
        </p:nvSpPr>
        <p:spPr>
          <a:xfrm rot="10800000">
            <a:off x="345621" y="6791439"/>
            <a:ext cx="369332" cy="63925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 weeks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9" name="그림 148"/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96" t="8458" r="34100" b="7009"/>
          <a:stretch/>
        </p:blipFill>
        <p:spPr>
          <a:xfrm>
            <a:off x="2563323" y="6376171"/>
            <a:ext cx="2006958" cy="1914835"/>
          </a:xfrm>
          <a:prstGeom prst="rect">
            <a:avLst/>
          </a:prstGeom>
        </p:spPr>
      </p:pic>
      <p:pic>
        <p:nvPicPr>
          <p:cNvPr id="150" name="그림 149"/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698" t="18628" r="33596" b="10203"/>
          <a:stretch/>
        </p:blipFill>
        <p:spPr>
          <a:xfrm>
            <a:off x="4742018" y="6376170"/>
            <a:ext cx="1922704" cy="1818774"/>
          </a:xfrm>
          <a:prstGeom prst="rect">
            <a:avLst/>
          </a:prstGeom>
        </p:spPr>
      </p:pic>
      <p:pic>
        <p:nvPicPr>
          <p:cNvPr id="151" name="그림 150"/>
          <p:cNvPicPr>
            <a:picLocks noChangeAspect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705" t="17756" r="33375" b="10784"/>
          <a:stretch/>
        </p:blipFill>
        <p:spPr>
          <a:xfrm>
            <a:off x="6610001" y="6376170"/>
            <a:ext cx="2129297" cy="1818775"/>
          </a:xfrm>
          <a:prstGeom prst="rect">
            <a:avLst/>
          </a:prstGeom>
        </p:spPr>
      </p:pic>
      <p:sp>
        <p:nvSpPr>
          <p:cNvPr id="152" name="TextBox 151"/>
          <p:cNvSpPr txBox="1"/>
          <p:nvPr/>
        </p:nvSpPr>
        <p:spPr>
          <a:xfrm rot="10800000">
            <a:off x="345621" y="8424816"/>
            <a:ext cx="369332" cy="104127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weeks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53" name="그림 152"/>
          <p:cNvPicPr>
            <a:picLocks noChangeAspect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601" r="28942"/>
          <a:stretch/>
        </p:blipFill>
        <p:spPr>
          <a:xfrm>
            <a:off x="703820" y="8314326"/>
            <a:ext cx="1861573" cy="1741302"/>
          </a:xfrm>
          <a:prstGeom prst="rect">
            <a:avLst/>
          </a:prstGeom>
        </p:spPr>
      </p:pic>
      <p:pic>
        <p:nvPicPr>
          <p:cNvPr id="154" name="그림 153"/>
          <p:cNvPicPr>
            <a:picLocks noChangeAspect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932" t="7958" r="34372" b="8258"/>
          <a:stretch/>
        </p:blipFill>
        <p:spPr>
          <a:xfrm>
            <a:off x="2594027" y="8387858"/>
            <a:ext cx="1976255" cy="1869069"/>
          </a:xfrm>
          <a:prstGeom prst="rect">
            <a:avLst/>
          </a:prstGeom>
        </p:spPr>
      </p:pic>
      <p:pic>
        <p:nvPicPr>
          <p:cNvPr id="155" name="그림 154"/>
          <p:cNvPicPr>
            <a:picLocks noChangeAspect="1"/>
          </p:cNvPicPr>
          <p:nvPr/>
        </p:nvPicPr>
        <p:blipFill rotWithShape="1"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108" t="19476" r="34079" b="11526"/>
          <a:stretch/>
        </p:blipFill>
        <p:spPr>
          <a:xfrm>
            <a:off x="4718054" y="8424815"/>
            <a:ext cx="1946667" cy="1782391"/>
          </a:xfrm>
          <a:prstGeom prst="rect">
            <a:avLst/>
          </a:prstGeom>
        </p:spPr>
      </p:pic>
      <p:pic>
        <p:nvPicPr>
          <p:cNvPr id="156" name="그림 155"/>
          <p:cNvPicPr>
            <a:picLocks noChangeAspect="1"/>
          </p:cNvPicPr>
          <p:nvPr/>
        </p:nvPicPr>
        <p:blipFill rotWithShape="1"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292" t="19475" r="34197" b="11209"/>
          <a:stretch/>
        </p:blipFill>
        <p:spPr>
          <a:xfrm>
            <a:off x="6573085" y="8424814"/>
            <a:ext cx="2171105" cy="1820388"/>
          </a:xfrm>
          <a:prstGeom prst="rect">
            <a:avLst/>
          </a:prstGeom>
        </p:spPr>
      </p:pic>
      <p:pic>
        <p:nvPicPr>
          <p:cNvPr id="158" name="그림 157"/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3551650" y="10365046"/>
            <a:ext cx="256248" cy="266498"/>
          </a:xfrm>
          <a:prstGeom prst="rect">
            <a:avLst/>
          </a:prstGeom>
        </p:spPr>
      </p:pic>
      <p:pic>
        <p:nvPicPr>
          <p:cNvPr id="159" name="그림 158"/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4622127" y="10376338"/>
            <a:ext cx="256248" cy="266498"/>
          </a:xfrm>
          <a:prstGeom prst="rect">
            <a:avLst/>
          </a:prstGeom>
        </p:spPr>
      </p:pic>
      <p:sp>
        <p:nvSpPr>
          <p:cNvPr id="160" name="TextBox 159"/>
          <p:cNvSpPr txBox="1"/>
          <p:nvPr/>
        </p:nvSpPr>
        <p:spPr>
          <a:xfrm>
            <a:off x="3807898" y="10336713"/>
            <a:ext cx="2078182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inese</a:t>
            </a:r>
            <a:endParaRPr lang="ko-KR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1" name="TextBox 160"/>
          <p:cNvSpPr txBox="1"/>
          <p:nvPr/>
        </p:nvSpPr>
        <p:spPr>
          <a:xfrm>
            <a:off x="4878375" y="10342914"/>
            <a:ext cx="2078182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orean</a:t>
            </a:r>
            <a:endParaRPr lang="ko-KR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9084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2</TotalTime>
  <Words>21</Words>
  <Application>Microsoft Office PowerPoint</Application>
  <PresentationFormat>사용자 지정</PresentationFormat>
  <Paragraphs>12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ae-Won Lee</dc:creator>
  <cp:lastModifiedBy>Hae-Won Lee</cp:lastModifiedBy>
  <cp:revision>44</cp:revision>
  <dcterms:created xsi:type="dcterms:W3CDTF">2016-12-20T13:33:55Z</dcterms:created>
  <dcterms:modified xsi:type="dcterms:W3CDTF">2017-01-09T02:51:55Z</dcterms:modified>
</cp:coreProperties>
</file>